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95" r:id="rId3"/>
    <p:sldId id="296" r:id="rId4"/>
    <p:sldId id="29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0" d="100"/>
          <a:sy n="90" d="100"/>
        </p:scale>
        <p:origin x="96" y="10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9CC18-C3B2-3E1A-339C-2B582E23D77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CBE9EE-2ABC-241E-9C55-69ED49E5C5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EBC04D-6E6D-D5E5-D00E-30D1B6665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0F0A5-57FE-9633-34C7-6AB6E68FF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497D3F-E7AE-139E-9BF1-3927FDDE4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356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FF15B7-AFCD-6393-1635-8CAF5CA765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18FE4E-81E4-9DCE-9A08-F69659F3F5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2B0783-DE3A-3846-AD1B-D13F0B858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22FDE3-5B89-6B7E-0B7F-138A1E96AA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AFEDC-E270-C651-5DE0-BD2DE133E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001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7DAFA9E-BE0A-87FF-5873-82282C302B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7193B8-2509-363A-BBDF-E1AD9A9404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612773-F89E-6D58-DD09-24C4A05AE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45396D-A569-552A-DD7A-401566CC0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2383DE-E016-126D-0C4A-8D15D9E78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707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E83B1-9B21-EC54-F675-ADF7C50EE9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B47A0C-2B2D-247F-75FD-37D875C1CA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1DD3C4-E0A7-C3E9-46EA-E8EA98B3A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AABFF9-51E7-2803-2EB9-F8CFE57B4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617F62-C154-4E03-51BA-A187C33E6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861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5880F-B57E-DBC7-DFCF-B10E69C49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83A46D-F762-F77C-F890-C1FB33B8A2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3DB20B-7201-7885-2F6D-B9DE19FF7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18042F-B88A-CFC9-A162-7C426A49D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BD07F6-6873-F7E2-B11A-EE90FA622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273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28F99B-D813-0B56-EB14-C1E9AE148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63973A-69BC-439D-2A3B-724458D355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2788A7-AB8E-455B-BE73-663F3D27D8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03C7C1-A5CF-0311-2311-1134EC79A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71C753-F2D7-2593-AC09-98C19ABD1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05E245-261D-50AD-CAC8-26443A242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797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62B376-120D-17BA-889F-1505F9F82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F351CB-54AA-D662-D4C6-E198F62738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798993-FB41-7C8F-528D-C804207B84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3076BC-7325-52F5-1332-839C733312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60B4A07-1CF1-E0A5-DE34-7A407DB993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CB9003-411C-65E7-A05F-723F3CE0D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C06124-15A9-AD35-6997-2179850F5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B3E9B7-AED6-2AB3-2F20-E803B8B2F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889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27F31-27F4-4AC3-F941-ED753BDFA5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E23FF90-87BE-F167-CC06-685EF588D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E822DB-5BB4-B4FA-07F8-1F3D9AE45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A0C47A-16D1-D886-C943-5B41E7261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359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DF1D403-B00E-FD0A-22F7-0A1BBB7F8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705EEB-1F2A-6464-B8E7-FAA021431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6C1DBA5-3144-7C2D-D676-AFFBD364E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730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0D764-4DC9-638B-2516-247EEF79CC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279D4F-4A48-E2BC-C712-1294A634DE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8BB55B-F08E-F50B-2A92-A93E218988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274CED-1A56-EFBE-89A1-9C8D5E225C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53787C-6E97-405B-9239-6E43758A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BBF1DB-E1E3-938E-8E17-96722EDC0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443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FBC05-5DE7-5DCC-EBB0-7ED2BDFC73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B28904F-46C1-D684-6A2F-436ACFB010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C96201-0953-98E6-E963-45DD3EAD81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CC939-1F7A-C3E3-79FC-EB1401FBC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4491F8-B099-A281-25C4-BAD93EB71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025A2F-591B-A92A-3DA5-CE73B57A2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685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EC5F678-040A-EE7F-7C3D-A917C28D7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CB861E-A8DE-4BDD-29D3-73F7CDA1F0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01627D-E80B-26A6-5C23-A1BBB5279C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CB0C9-91F0-4BB1-A8FA-AE5EAC9FF4C5}" type="datetimeFigureOut">
              <a:rPr lang="en-US" smtClean="0"/>
              <a:t>10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E08060-CBAA-EE1C-9B42-BDD6F62547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585ABC-655F-419E-ADED-3EEBA86E2A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AD665A-B657-4BF6-B826-C31ACC6D57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128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C09D52-27EA-CE50-F034-771CCD81F8A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1800"/>
              </a:spcAft>
            </a:pPr>
            <a:r>
              <a:rPr lang="en-US" sz="2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ticle: Comparison of ultrastructure, ECM, and drug susceptibility in </a:t>
            </a:r>
            <a:r>
              <a:rPr lang="en-US" sz="24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. avium </a:t>
            </a:r>
            <a:r>
              <a:rPr lang="en-US" sz="2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bs. </a:t>
            </a:r>
            <a:r>
              <a:rPr lang="en-US" sz="24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ominissuis</a:t>
            </a:r>
            <a:r>
              <a:rPr lang="en-US" sz="2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iofilm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4738AE-7168-4EC9-5817-2CBBD728C19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8836941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B4DAED6-89EF-1DEE-D59B-46C7B49FE6E7}"/>
              </a:ext>
            </a:extLst>
          </p:cNvPr>
          <p:cNvSpPr txBox="1"/>
          <p:nvPr/>
        </p:nvSpPr>
        <p:spPr>
          <a:xfrm>
            <a:off x="208464" y="4207889"/>
            <a:ext cx="4956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Additional images of DTT induced biofilm, showing visible bacteria cel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M was carried out o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avi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ktonic or biofilm samples grown on glass coverslips. In some areas of the biofilm samples, or in areas where the homogenous layer of material was disrupted, abundan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avi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cteria are visible.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5BA3478-47E7-EAFA-876F-0D35E1B6A1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265" y="291456"/>
            <a:ext cx="4127491" cy="3801000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6DA684A5-4B13-E730-4127-B3BBB44A5E51}"/>
              </a:ext>
            </a:extLst>
          </p:cNvPr>
          <p:cNvGrpSpPr/>
          <p:nvPr/>
        </p:nvGrpSpPr>
        <p:grpSpPr>
          <a:xfrm>
            <a:off x="292608" y="3850479"/>
            <a:ext cx="4115148" cy="263410"/>
            <a:chOff x="219455" y="2095438"/>
            <a:chExt cx="3776195" cy="263410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7B21B215-D16C-EFEA-192F-DAC9A303FC50}"/>
                </a:ext>
              </a:extLst>
            </p:cNvPr>
            <p:cNvSpPr/>
            <p:nvPr/>
          </p:nvSpPr>
          <p:spPr>
            <a:xfrm>
              <a:off x="219455" y="2116871"/>
              <a:ext cx="3776195" cy="22054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27"/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3BFB920F-2319-8628-8B6B-FFA6EEFEE825}"/>
                </a:ext>
              </a:extLst>
            </p:cNvPr>
            <p:cNvCxnSpPr>
              <a:cxnSpLocks/>
            </p:cNvCxnSpPr>
            <p:nvPr/>
          </p:nvCxnSpPr>
          <p:spPr>
            <a:xfrm>
              <a:off x="1726582" y="2155010"/>
              <a:ext cx="161060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6D63845-78A4-526F-FCB2-0625F7AB1037}"/>
                </a:ext>
              </a:extLst>
            </p:cNvPr>
            <p:cNvSpPr txBox="1"/>
            <p:nvPr/>
          </p:nvSpPr>
          <p:spPr>
            <a:xfrm>
              <a:off x="324850" y="2095438"/>
              <a:ext cx="6113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</a:rPr>
                <a:t>10,000x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2A41C38-66EA-6003-98FD-049910D969B2}"/>
                </a:ext>
              </a:extLst>
            </p:cNvPr>
            <p:cNvSpPr txBox="1"/>
            <p:nvPr/>
          </p:nvSpPr>
          <p:spPr>
            <a:xfrm>
              <a:off x="2286749" y="2128016"/>
              <a:ext cx="6113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</a:rPr>
                <a:t>10 </a:t>
              </a:r>
              <a:r>
                <a:rPr lang="el-GR" sz="900" dirty="0">
                  <a:solidFill>
                    <a:schemeClr val="bg1"/>
                  </a:solidFill>
                </a:rPr>
                <a:t>μ</a:t>
              </a:r>
              <a:r>
                <a:rPr lang="en-US" sz="900" dirty="0">
                  <a:solidFill>
                    <a:schemeClr val="bg1"/>
                  </a:solidFill>
                </a:rPr>
                <a:t>m</a:t>
              </a:r>
            </a:p>
          </p:txBody>
        </p:sp>
      </p:grpSp>
      <p:pic>
        <p:nvPicPr>
          <p:cNvPr id="18" name="Picture 17">
            <a:extLst>
              <a:ext uri="{FF2B5EF4-FFF2-40B4-BE49-F238E27FC236}">
                <a16:creationId xmlns:a16="http://schemas.microsoft.com/office/drawing/2014/main" id="{C4199170-032F-80A0-68CE-134A3865EB5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9191" y="291456"/>
            <a:ext cx="4127491" cy="3801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867131C-B3FB-A6DE-70BE-3E7FB5F9D20E}"/>
              </a:ext>
            </a:extLst>
          </p:cNvPr>
          <p:cNvSpPr txBox="1"/>
          <p:nvPr/>
        </p:nvSpPr>
        <p:spPr>
          <a:xfrm>
            <a:off x="280265" y="253964"/>
            <a:ext cx="839908" cy="2811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27" dirty="0">
                <a:latin typeface="Times New Roman" panose="02020603050405020304" pitchFamily="18" charset="0"/>
                <a:cs typeface="Times New Roman" panose="02020603050405020304" pitchFamily="18" charset="0"/>
              </a:rPr>
              <a:t>A5 DT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4990637-ED72-76D9-5642-8BE06BB7B074}"/>
              </a:ext>
            </a:extLst>
          </p:cNvPr>
          <p:cNvSpPr txBox="1"/>
          <p:nvPr/>
        </p:nvSpPr>
        <p:spPr>
          <a:xfrm>
            <a:off x="4549191" y="291456"/>
            <a:ext cx="839908" cy="2811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27" dirty="0">
                <a:latin typeface="Times New Roman" panose="02020603050405020304" pitchFamily="18" charset="0"/>
                <a:cs typeface="Times New Roman" panose="02020603050405020304" pitchFamily="18" charset="0"/>
              </a:rPr>
              <a:t>A5 DTT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AB72A97D-1FAE-230E-A7B5-51A1696E9A06}"/>
              </a:ext>
            </a:extLst>
          </p:cNvPr>
          <p:cNvGrpSpPr/>
          <p:nvPr/>
        </p:nvGrpSpPr>
        <p:grpSpPr>
          <a:xfrm>
            <a:off x="4555362" y="3850479"/>
            <a:ext cx="4115148" cy="263410"/>
            <a:chOff x="213791" y="2095438"/>
            <a:chExt cx="3776195" cy="263410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E900E89C-5D5C-553D-D914-0EC163FBA86B}"/>
                </a:ext>
              </a:extLst>
            </p:cNvPr>
            <p:cNvSpPr/>
            <p:nvPr/>
          </p:nvSpPr>
          <p:spPr>
            <a:xfrm>
              <a:off x="213791" y="2116871"/>
              <a:ext cx="3776195" cy="22054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27" dirty="0"/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37D3F00E-4E09-1FAE-2C98-9C71E9937D8F}"/>
                </a:ext>
              </a:extLst>
            </p:cNvPr>
            <p:cNvCxnSpPr>
              <a:cxnSpLocks/>
            </p:cNvCxnSpPr>
            <p:nvPr/>
          </p:nvCxnSpPr>
          <p:spPr>
            <a:xfrm>
              <a:off x="1822692" y="2163781"/>
              <a:ext cx="148318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0007003-A158-4D1F-E143-0B8C0C5FAAD2}"/>
                </a:ext>
              </a:extLst>
            </p:cNvPr>
            <p:cNvSpPr txBox="1"/>
            <p:nvPr/>
          </p:nvSpPr>
          <p:spPr>
            <a:xfrm>
              <a:off x="324850" y="2095438"/>
              <a:ext cx="6113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</a:rPr>
                <a:t>10,000x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8E68C22-1129-86D2-EC4E-25DE97BBDC4D}"/>
                </a:ext>
              </a:extLst>
            </p:cNvPr>
            <p:cNvSpPr txBox="1"/>
            <p:nvPr/>
          </p:nvSpPr>
          <p:spPr>
            <a:xfrm>
              <a:off x="2286749" y="2128016"/>
              <a:ext cx="6113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solidFill>
                    <a:schemeClr val="bg1"/>
                  </a:solidFill>
                </a:rPr>
                <a:t>10 </a:t>
              </a:r>
              <a:r>
                <a:rPr lang="el-GR" sz="900" dirty="0">
                  <a:solidFill>
                    <a:schemeClr val="bg1"/>
                  </a:solidFill>
                </a:rPr>
                <a:t>μ</a:t>
              </a:r>
              <a:r>
                <a:rPr lang="en-US" sz="900" dirty="0">
                  <a:solidFill>
                    <a:schemeClr val="bg1"/>
                  </a:solidFill>
                </a:rPr>
                <a:t>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136378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D779BB3-EDFF-EC35-DC1D-4DD93B558F7A}"/>
              </a:ext>
            </a:extLst>
          </p:cNvPr>
          <p:cNvSpPr txBox="1"/>
          <p:nvPr/>
        </p:nvSpPr>
        <p:spPr>
          <a:xfrm>
            <a:off x="7325056" y="1655605"/>
            <a:ext cx="48669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Antibiotic susceptibility assessment raw CFU plot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aviu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 A5 and 2151 grown in planktonic culture, DTT biofilm, or M63 biofilm were exposed to varying concentrations of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kacin or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larithromycin for 4 days. After 4 days, supernatants were removed and biofilms were disrupted by scraping, pipetting, and vortexing, and dilutions of each sample were plated on 7H10 agar +10% OADC to quantify CFU. The plot shows average CFU in each condition and standard deviation for 3-4 biological replicates. 0, t=0 shows the CFU present in each condition at the initiation of the four day incubation period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ED16DF5-C4E0-1C13-AF8D-AD1BA0FE15CA}"/>
              </a:ext>
            </a:extLst>
          </p:cNvPr>
          <p:cNvSpPr txBox="1"/>
          <p:nvPr/>
        </p:nvSpPr>
        <p:spPr>
          <a:xfrm>
            <a:off x="0" y="-94614"/>
            <a:ext cx="20005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C700DBFE-78B3-BECB-EF57-DAE1161513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2095854"/>
              </p:ext>
            </p:extLst>
          </p:nvPr>
        </p:nvGraphicFramePr>
        <p:xfrm>
          <a:off x="-131762" y="3085464"/>
          <a:ext cx="7985125" cy="298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7985649" imgH="2982075" progId="Prism9.Document">
                  <p:embed/>
                </p:oleObj>
              </mc:Choice>
              <mc:Fallback>
                <p:oleObj name="Prism 9" r:id="rId3" imgW="7985649" imgH="298207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31762" y="3085464"/>
                        <a:ext cx="7985125" cy="298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46247FB4-A7F5-A883-276C-DC1561A695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8993766"/>
              </p:ext>
            </p:extLst>
          </p:nvPr>
        </p:nvGraphicFramePr>
        <p:xfrm>
          <a:off x="-131762" y="166996"/>
          <a:ext cx="8031163" cy="298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5" imgW="8031387" imgH="2982075" progId="Prism9.Document">
                  <p:embed/>
                </p:oleObj>
              </mc:Choice>
              <mc:Fallback>
                <p:oleObj name="Prism 9" r:id="rId5" imgW="8031387" imgH="298207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131762" y="166996"/>
                        <a:ext cx="8031163" cy="298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862276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4967BB2-2FE3-E5F1-6733-51A6BBE0462E}"/>
              </a:ext>
            </a:extLst>
          </p:cNvPr>
          <p:cNvSpPr txBox="1"/>
          <p:nvPr/>
        </p:nvSpPr>
        <p:spPr>
          <a:xfrm>
            <a:off x="0" y="0"/>
            <a:ext cx="20005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922A508-F5D3-0CC7-0A19-62E31D484C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6222913"/>
              </p:ext>
            </p:extLst>
          </p:nvPr>
        </p:nvGraphicFramePr>
        <p:xfrm>
          <a:off x="-142875" y="2955926"/>
          <a:ext cx="7985125" cy="298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9" r:id="rId3" imgW="7985649" imgH="2982075" progId="Prism9.Document">
                  <p:embed/>
                </p:oleObj>
              </mc:Choice>
              <mc:Fallback>
                <p:oleObj name="Prism 9" r:id="rId3" imgW="7985649" imgH="298207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42875" y="2955926"/>
                        <a:ext cx="7985125" cy="298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D9C1082-4F5E-6282-448E-D010CA610A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7759613"/>
              </p:ext>
            </p:extLst>
          </p:nvPr>
        </p:nvGraphicFramePr>
        <p:xfrm>
          <a:off x="-142875" y="120650"/>
          <a:ext cx="7904163" cy="298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9" r:id="rId5" imgW="7903538" imgH="2982075" progId="Prism9.Document">
                  <p:embed/>
                </p:oleObj>
              </mc:Choice>
              <mc:Fallback>
                <p:oleObj name="Prism 9" r:id="rId5" imgW="7903538" imgH="298207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142875" y="120650"/>
                        <a:ext cx="7904163" cy="298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9889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217</Words>
  <Application>Microsoft Office PowerPoint</Application>
  <PresentationFormat>Widescreen</PresentationFormat>
  <Paragraphs>12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9</vt:lpstr>
      <vt:lpstr>Article: Comparison of ultrastructure, ECM, and drug susceptibility in M. avium subs. hominissuis biofilms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rticle: Comparison of ultrastructure, ECM, and drug susceptibility in M. avium subs. hominissuis biofilms</dc:title>
  <dc:creator>15742993822</dc:creator>
  <cp:lastModifiedBy>Jeffrey Schorey</cp:lastModifiedBy>
  <cp:revision>2</cp:revision>
  <dcterms:created xsi:type="dcterms:W3CDTF">2023-10-05T14:01:49Z</dcterms:created>
  <dcterms:modified xsi:type="dcterms:W3CDTF">2023-10-17T14:13:01Z</dcterms:modified>
</cp:coreProperties>
</file>